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4D8634-2F93-4522-B732-57E38E2AB10E}" v="1" dt="2023-10-06T23:27:27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576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delhamid, Ahmed" userId="3492e8a2-3206-4319-8bdd-822c9fed79a3" providerId="ADAL" clId="{594D8634-2F93-4522-B732-57E38E2AB10E}"/>
    <pc:docChg chg="modSld">
      <pc:chgData name="Abdelhamid, Ahmed" userId="3492e8a2-3206-4319-8bdd-822c9fed79a3" providerId="ADAL" clId="{594D8634-2F93-4522-B732-57E38E2AB10E}" dt="2023-10-06T23:28:51.233" v="157" actId="20577"/>
      <pc:docMkLst>
        <pc:docMk/>
      </pc:docMkLst>
      <pc:sldChg chg="modSp mod">
        <pc:chgData name="Abdelhamid, Ahmed" userId="3492e8a2-3206-4319-8bdd-822c9fed79a3" providerId="ADAL" clId="{594D8634-2F93-4522-B732-57E38E2AB10E}" dt="2023-10-06T23:28:51.233" v="157" actId="20577"/>
        <pc:sldMkLst>
          <pc:docMk/>
          <pc:sldMk cId="1741538652" sldId="268"/>
        </pc:sldMkLst>
        <pc:spChg chg="mod">
          <ac:chgData name="Abdelhamid, Ahmed" userId="3492e8a2-3206-4319-8bdd-822c9fed79a3" providerId="ADAL" clId="{594D8634-2F93-4522-B732-57E38E2AB10E}" dt="2023-10-06T23:28:51.233" v="157" actId="20577"/>
          <ac:spMkLst>
            <pc:docMk/>
            <pc:sldMk cId="1741538652" sldId="268"/>
            <ac:spMk id="7" creationId="{B88716CA-06BA-6BFC-5897-9D59183B6121}"/>
          </ac:spMkLst>
        </pc:spChg>
        <pc:spChg chg="mod">
          <ac:chgData name="Abdelhamid, Ahmed" userId="3492e8a2-3206-4319-8bdd-822c9fed79a3" providerId="ADAL" clId="{594D8634-2F93-4522-B732-57E38E2AB10E}" dt="2023-10-06T23:28:44.865" v="149" actId="20577"/>
          <ac:spMkLst>
            <pc:docMk/>
            <pc:sldMk cId="1741538652" sldId="268"/>
            <ac:spMk id="11" creationId="{693EF7B9-3B60-88F9-4DC8-7F39726EFAF3}"/>
          </ac:spMkLst>
        </pc:spChg>
        <pc:spChg chg="mod">
          <ac:chgData name="Abdelhamid, Ahmed" userId="3492e8a2-3206-4319-8bdd-822c9fed79a3" providerId="ADAL" clId="{594D8634-2F93-4522-B732-57E38E2AB10E}" dt="2023-10-06T23:28:32.386" v="138" actId="20577"/>
          <ac:spMkLst>
            <pc:docMk/>
            <pc:sldMk cId="1741538652" sldId="268"/>
            <ac:spMk id="12" creationId="{9C426459-3D8F-6E1A-9364-431D6F639599}"/>
          </ac:spMkLst>
        </pc:spChg>
        <pc:grpChg chg="mod">
          <ac:chgData name="Abdelhamid, Ahmed" userId="3492e8a2-3206-4319-8bdd-822c9fed79a3" providerId="ADAL" clId="{594D8634-2F93-4522-B732-57E38E2AB10E}" dt="2023-10-06T23:28:42.055" v="147" actId="14100"/>
          <ac:grpSpMkLst>
            <pc:docMk/>
            <pc:sldMk cId="1741538652" sldId="268"/>
            <ac:grpSpMk id="6" creationId="{200520B3-4117-CC94-D61D-8253446790B9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0FCBA-CEE8-984F-0E5A-4A7809D0BB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EB0B25-0FD8-798F-19CA-1F95F5F77B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625E7-C154-D1FD-1C0D-E34DB82C3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080BA-76EE-46E4-D25E-9DA116FE6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8FF89F-7D3A-5C8B-CFA8-E40CB82F8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09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144F15-B07F-357B-56EA-A65924D5A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E54909-E65F-5FC2-D221-83E7573E0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7B3B53-C769-608D-719F-EF401F59B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075FC9-6500-68F1-2A56-834D0C085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7127C-8376-BE33-F905-A9B36D186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601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AAFE86-625A-679E-4D63-FE3A9808B0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5B04F4-DAF9-A3F5-E44B-26FFE22FC5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21DED2-E3AB-E227-670C-64B3E60DC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0EE3B-D7F1-3CDC-9ECD-FD0FA4368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F9C49-2029-BBD2-C263-818E80458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773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05B4F-B250-473D-D1B4-A4CA3091A9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FA597E-2694-B1ED-0707-44F6901D8E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939DDF-8DE8-8651-0A8E-8A52DF1E7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50F95-5DF8-EDDD-497E-77ED022C3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9C3445-9B2E-D5BD-AB62-F60734827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272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EC2214-B166-4004-2E80-21345C0243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A6C8F4-FEF3-1278-9628-F3FA646267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C994B5-C6EE-C6CA-ED3C-CA93B6AE4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D30ED-548B-AFB0-E562-3AFF707A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B281F0-A73D-AA2E-7F14-7B4218802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172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F2DC0-13F7-1DE8-7F2A-609D571C83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6912A3-097C-A8F4-AF41-94F5D88C41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795CC3-C3BF-EC6B-2379-D2C1DBFEF7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86037B-C2B6-9D69-0AFD-AE3A9FD1F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6842D8-2B66-66C5-2946-E249FEA59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28C52B-B649-4CF0-1AC9-3C7F8350D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1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6B736D-6317-59A5-DEF2-ED1AECB2C4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818299-0A42-248D-C37C-72B45C391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E654E5-0164-DA07-F6A3-17BE3E3FB1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035A14-3E5D-D6D2-093E-3E6FCCBB76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F06031-5485-E401-1068-8E7C9AC542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6CD507-1806-25B7-39F3-9D63FD9B7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DC6F69-60FF-D7CA-D18C-B76EB3D0E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65E450-74A1-D93A-90FF-466E3263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884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0201AB-AEF7-DB2C-4FE6-B1C308B9E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BEAB79-34BE-E176-A788-3BD88E6F2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233031-3C58-9BD9-7144-130F0565A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CB8AF1-9D74-75BF-6541-498CD8ADD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05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E30D4B-667A-84CA-D72B-58D10352A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C49E43-EB3A-2425-5B3B-5D8C33028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F93185-FC94-9A01-80FB-903437598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72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A370D-C0AE-9C28-B718-037F00A2D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B55540-7320-AB69-CC09-BBE1D43D9D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CB8302-B757-F8C0-5066-8226404A13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51482B-B8B2-6D4A-591C-E7A1542E4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E4E199-1C1B-EE72-3B58-834A08C3D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9CF60A-2554-F2CB-4BC3-29699BDFD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95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23E9DC-4246-7FA9-94C8-787863E71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2B9B07-556D-1AAF-C3BE-CAECC5EDA0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B3B8C1-9E92-A02F-ED97-5B13BE2A6B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D49131-92E4-89A7-0DCE-8BA203084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911BFF-BEE3-858B-6E04-8FBF36040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0AFEFE-61A4-4515-2E8B-846E8590C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022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B360D4-4443-F07A-08DD-54A016F21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4546F9-A01B-6239-9AA0-D9739A6DDA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53173D-C2B9-BEEE-F2B1-FC099D3340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7E2DC-B607-44A1-9E05-A902C898A4BC}" type="datetimeFigureOut">
              <a:rPr lang="en-US" smtClean="0"/>
              <a:t>10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CB90D-5CF2-12B2-6031-F92B938340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77ED6A-8427-10D5-CBDC-9DA5BB96AA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1EA66-8B66-459D-BD5B-1BF0296D2A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388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4C30BB2-BC99-F74C-8F55-DCDD310E057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92266" y="-91440"/>
          <a:ext cx="3965890" cy="7040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598213" imgH="8167573" progId="Prism9.Document">
                  <p:embed/>
                </p:oleObj>
              </mc:Choice>
              <mc:Fallback>
                <p:oleObj name="Prism 9" r:id="rId2" imgW="4598213" imgH="8167573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24C30BB2-BC99-F74C-8F55-DCDD310E05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92266" y="-91440"/>
                        <a:ext cx="3965890" cy="7040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200520B3-4117-CC94-D61D-8253446790B9}"/>
              </a:ext>
            </a:extLst>
          </p:cNvPr>
          <p:cNvGrpSpPr/>
          <p:nvPr/>
        </p:nvGrpSpPr>
        <p:grpSpPr>
          <a:xfrm>
            <a:off x="3382392" y="6260688"/>
            <a:ext cx="1731545" cy="495712"/>
            <a:chOff x="6971796" y="-46729"/>
            <a:chExt cx="1941845" cy="63537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88716CA-06BA-6BFC-5897-9D59183B6121}"/>
                </a:ext>
              </a:extLst>
            </p:cNvPr>
            <p:cNvSpPr txBox="1"/>
            <p:nvPr/>
          </p:nvSpPr>
          <p:spPr>
            <a:xfrm>
              <a:off x="7207199" y="194157"/>
              <a:ext cx="1543955" cy="3944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Replicon absent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FE1CB99-D814-E1EF-8B2C-85B92C1AE87C}"/>
                </a:ext>
              </a:extLst>
            </p:cNvPr>
            <p:cNvGrpSpPr/>
            <p:nvPr/>
          </p:nvGrpSpPr>
          <p:grpSpPr>
            <a:xfrm>
              <a:off x="6971796" y="-46729"/>
              <a:ext cx="1941845" cy="477693"/>
              <a:chOff x="6971796" y="-46729"/>
              <a:chExt cx="1941845" cy="477693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74DF37C9-70D6-AD00-A124-0A765D0867CE}"/>
                  </a:ext>
                </a:extLst>
              </p:cNvPr>
              <p:cNvSpPr/>
              <p:nvPr/>
            </p:nvSpPr>
            <p:spPr>
              <a:xfrm>
                <a:off x="6971796" y="325481"/>
                <a:ext cx="287383" cy="105483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0B0B3F1A-CDDA-5C52-62BB-CFDE5CF06BFF}"/>
                  </a:ext>
                </a:extLst>
              </p:cNvPr>
              <p:cNvSpPr/>
              <p:nvPr/>
            </p:nvSpPr>
            <p:spPr>
              <a:xfrm>
                <a:off x="6971796" y="98749"/>
                <a:ext cx="287383" cy="105483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93EF7B9-3B60-88F9-4DC8-7F39726EFAF3}"/>
                  </a:ext>
                </a:extLst>
              </p:cNvPr>
              <p:cNvSpPr txBox="1"/>
              <p:nvPr/>
            </p:nvSpPr>
            <p:spPr>
              <a:xfrm>
                <a:off x="7213307" y="-46729"/>
                <a:ext cx="1700334" cy="3944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Replicon present</a:t>
                </a:r>
              </a:p>
            </p:txBody>
          </p:sp>
        </p:grp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9C426459-3D8F-6E1A-9364-431D6F639599}"/>
              </a:ext>
            </a:extLst>
          </p:cNvPr>
          <p:cNvSpPr txBox="1"/>
          <p:nvPr/>
        </p:nvSpPr>
        <p:spPr>
          <a:xfrm>
            <a:off x="165178" y="290766"/>
            <a:ext cx="396589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le 2: Presence/absence of </a:t>
            </a:r>
          </a:p>
          <a:p>
            <a:pPr algn="just"/>
            <a:r>
              <a:rPr lang="en-US" sz="1200" b="1" dirty="0"/>
              <a:t>plasmid replicons in 94 </a:t>
            </a:r>
            <a:r>
              <a:rPr lang="en-US" sz="1200" b="1" i="1" dirty="0"/>
              <a:t>Salmonella</a:t>
            </a:r>
            <a:r>
              <a:rPr lang="en-US" sz="1200" b="1" dirty="0"/>
              <a:t> Enteritidis strains including the 74 strains from eggs. Plasmid replicons were identified as "present" using ABRicate with PlasmidFinder database at a minimum 80% identity and coverage.</a:t>
            </a:r>
          </a:p>
        </p:txBody>
      </p:sp>
    </p:spTree>
    <p:extLst>
      <p:ext uri="{BB962C8B-B14F-4D97-AF65-F5344CB8AC3E}">
        <p14:creationId xmlns:p14="http://schemas.microsoft.com/office/powerpoint/2010/main" val="1741538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elhamid, Ahmed</dc:creator>
  <cp:lastModifiedBy>Abdelhamid, Ahmed</cp:lastModifiedBy>
  <cp:revision>1</cp:revision>
  <dcterms:created xsi:type="dcterms:W3CDTF">2023-10-05T23:55:39Z</dcterms:created>
  <dcterms:modified xsi:type="dcterms:W3CDTF">2023-10-06T23:28:59Z</dcterms:modified>
</cp:coreProperties>
</file>